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69.xml" ContentType="application/vnd.openxmlformats-officedocument.presentationml.slide+xml"/>
  <Override PartName="/ppt/slides/slide70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74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77.xml" ContentType="application/vnd.openxmlformats-officedocument.presentationml.slide+xml"/>
  <Override PartName="/ppt/slides/slide78.xml" ContentType="application/vnd.openxmlformats-officedocument.presentationml.slide+xml"/>
  <Override PartName="/ppt/slides/slide79.xml" ContentType="application/vnd.openxmlformats-officedocument.presentationml.slide+xml"/>
  <Override PartName="/ppt/slides/slide80.xml" ContentType="application/vnd.openxmlformats-officedocument.presentationml.slide+xml"/>
  <Override PartName="/ppt/slides/slide81.xml" ContentType="application/vnd.openxmlformats-officedocument.presentationml.slide+xml"/>
  <Override PartName="/ppt/slides/slide8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notesSlides/notesSlide37.xml" ContentType="application/vnd.openxmlformats-officedocument.presentationml.notesSlide+xml"/>
  <Override PartName="/ppt/notesSlides/notesSlide38.xml" ContentType="application/vnd.openxmlformats-officedocument.presentationml.notesSlide+xml"/>
  <Override PartName="/ppt/notesSlides/notesSlide39.xml" ContentType="application/vnd.openxmlformats-officedocument.presentationml.notesSlide+xml"/>
  <Override PartName="/ppt/notesSlides/notesSlide40.xml" ContentType="application/vnd.openxmlformats-officedocument.presentationml.notesSlide+xml"/>
  <Override PartName="/ppt/notesSlides/notesSlide41.xml" ContentType="application/vnd.openxmlformats-officedocument.presentationml.notesSlide+xml"/>
  <Override PartName="/ppt/notesSlides/notesSlide42.xml" ContentType="application/vnd.openxmlformats-officedocument.presentationml.notesSlide+xml"/>
  <Override PartName="/ppt/notesSlides/notesSlide43.xml" ContentType="application/vnd.openxmlformats-officedocument.presentationml.notesSlide+xml"/>
  <Override PartName="/ppt/notesSlides/notesSlide44.xml" ContentType="application/vnd.openxmlformats-officedocument.presentationml.notesSlide+xml"/>
  <Override PartName="/ppt/notesSlides/notesSlide45.xml" ContentType="application/vnd.openxmlformats-officedocument.presentationml.notesSlide+xml"/>
  <Override PartName="/ppt/notesSlides/notesSlide46.xml" ContentType="application/vnd.openxmlformats-officedocument.presentationml.notesSlide+xml"/>
  <Override PartName="/ppt/notesSlides/notesSlide47.xml" ContentType="application/vnd.openxmlformats-officedocument.presentationml.notesSlide+xml"/>
  <Override PartName="/ppt/notesSlides/notesSlide48.xml" ContentType="application/vnd.openxmlformats-officedocument.presentationml.notesSlide+xml"/>
  <Override PartName="/ppt/notesSlides/notesSlide49.xml" ContentType="application/vnd.openxmlformats-officedocument.presentationml.notesSlide+xml"/>
  <Override PartName="/ppt/notesSlides/notesSlide50.xml" ContentType="application/vnd.openxmlformats-officedocument.presentationml.notesSlide+xml"/>
  <Override PartName="/ppt/notesSlides/notesSlide51.xml" ContentType="application/vnd.openxmlformats-officedocument.presentationml.notesSlide+xml"/>
  <Override PartName="/ppt/notesSlides/notesSlide52.xml" ContentType="application/vnd.openxmlformats-officedocument.presentationml.notesSlide+xml"/>
  <Override PartName="/ppt/notesSlides/notesSlide53.xml" ContentType="application/vnd.openxmlformats-officedocument.presentationml.notesSlide+xml"/>
  <Override PartName="/ppt/notesSlides/notesSlide54.xml" ContentType="application/vnd.openxmlformats-officedocument.presentationml.notesSlide+xml"/>
  <Override PartName="/ppt/notesSlides/notesSlide55.xml" ContentType="application/vnd.openxmlformats-officedocument.presentationml.notesSlide+xml"/>
  <Override PartName="/ppt/notesSlides/notesSlide56.xml" ContentType="application/vnd.openxmlformats-officedocument.presentationml.notesSlide+xml"/>
  <Override PartName="/ppt/notesSlides/notesSlide57.xml" ContentType="application/vnd.openxmlformats-officedocument.presentationml.notesSlide+xml"/>
  <Override PartName="/ppt/notesSlides/notesSlide58.xml" ContentType="application/vnd.openxmlformats-officedocument.presentationml.notesSlide+xml"/>
  <Override PartName="/ppt/notesSlides/notesSlide59.xml" ContentType="application/vnd.openxmlformats-officedocument.presentationml.notesSlide+xml"/>
  <Override PartName="/ppt/notesSlides/notesSlide60.xml" ContentType="application/vnd.openxmlformats-officedocument.presentationml.notesSlide+xml"/>
  <Override PartName="/ppt/notesSlides/notesSlide61.xml" ContentType="application/vnd.openxmlformats-officedocument.presentationml.notesSlide+xml"/>
  <Override PartName="/ppt/notesSlides/notesSlide62.xml" ContentType="application/vnd.openxmlformats-officedocument.presentationml.notesSlide+xml"/>
  <Override PartName="/ppt/notesSlides/notesSlide63.xml" ContentType="application/vnd.openxmlformats-officedocument.presentationml.notesSlide+xml"/>
  <Override PartName="/ppt/notesSlides/notesSlide64.xml" ContentType="application/vnd.openxmlformats-officedocument.presentationml.notesSlide+xml"/>
  <Override PartName="/ppt/notesSlides/notesSlide65.xml" ContentType="application/vnd.openxmlformats-officedocument.presentationml.notesSlide+xml"/>
  <Override PartName="/ppt/notesSlides/notesSlide66.xml" ContentType="application/vnd.openxmlformats-officedocument.presentationml.notesSlide+xml"/>
  <Override PartName="/ppt/notesSlides/notesSlide67.xml" ContentType="application/vnd.openxmlformats-officedocument.presentationml.notesSlide+xml"/>
  <Override PartName="/ppt/notesSlides/notesSlide68.xml" ContentType="application/vnd.openxmlformats-officedocument.presentationml.notesSlide+xml"/>
  <Override PartName="/ppt/notesSlides/notesSlide69.xml" ContentType="application/vnd.openxmlformats-officedocument.presentationml.notesSlide+xml"/>
  <Override PartName="/ppt/notesSlides/notesSlide70.xml" ContentType="application/vnd.openxmlformats-officedocument.presentationml.notesSlide+xml"/>
  <Override PartName="/ppt/notesSlides/notesSlide71.xml" ContentType="application/vnd.openxmlformats-officedocument.presentationml.notesSlide+xml"/>
  <Override PartName="/ppt/notesSlides/notesSlide72.xml" ContentType="application/vnd.openxmlformats-officedocument.presentationml.notesSlide+xml"/>
  <Override PartName="/ppt/notesSlides/notesSlide73.xml" ContentType="application/vnd.openxmlformats-officedocument.presentationml.notesSlide+xml"/>
  <Override PartName="/ppt/notesSlides/notesSlide74.xml" ContentType="application/vnd.openxmlformats-officedocument.presentationml.notesSlide+xml"/>
  <Override PartName="/ppt/notesSlides/notesSlide75.xml" ContentType="application/vnd.openxmlformats-officedocument.presentationml.notesSlide+xml"/>
  <Override PartName="/ppt/notesSlides/notesSlide76.xml" ContentType="application/vnd.openxmlformats-officedocument.presentationml.notesSlide+xml"/>
  <Override PartName="/ppt/notesSlides/notesSlide77.xml" ContentType="application/vnd.openxmlformats-officedocument.presentationml.notesSlide+xml"/>
  <Override PartName="/ppt/notesSlides/notesSlide78.xml" ContentType="application/vnd.openxmlformats-officedocument.presentationml.notesSlide+xml"/>
  <Override PartName="/ppt/notesSlides/notesSlide7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4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2" r:id="rId38"/>
    <p:sldId id="293" r:id="rId39"/>
    <p:sldId id="294" r:id="rId40"/>
    <p:sldId id="295" r:id="rId41"/>
    <p:sldId id="296" r:id="rId42"/>
    <p:sldId id="297" r:id="rId43"/>
    <p:sldId id="298" r:id="rId44"/>
    <p:sldId id="299" r:id="rId45"/>
    <p:sldId id="300" r:id="rId46"/>
    <p:sldId id="301" r:id="rId47"/>
    <p:sldId id="302" r:id="rId48"/>
    <p:sldId id="303" r:id="rId49"/>
    <p:sldId id="304" r:id="rId50"/>
    <p:sldId id="305" r:id="rId51"/>
    <p:sldId id="306" r:id="rId52"/>
    <p:sldId id="307" r:id="rId53"/>
    <p:sldId id="308" r:id="rId54"/>
    <p:sldId id="309" r:id="rId55"/>
    <p:sldId id="310" r:id="rId56"/>
    <p:sldId id="311" r:id="rId57"/>
    <p:sldId id="312" r:id="rId58"/>
    <p:sldId id="313" r:id="rId59"/>
    <p:sldId id="314" r:id="rId60"/>
    <p:sldId id="315" r:id="rId61"/>
    <p:sldId id="316" r:id="rId62"/>
    <p:sldId id="317" r:id="rId63"/>
    <p:sldId id="318" r:id="rId64"/>
    <p:sldId id="319" r:id="rId65"/>
    <p:sldId id="320" r:id="rId66"/>
    <p:sldId id="321" r:id="rId67"/>
    <p:sldId id="322" r:id="rId68"/>
    <p:sldId id="323" r:id="rId69"/>
    <p:sldId id="324" r:id="rId70"/>
    <p:sldId id="325" r:id="rId71"/>
    <p:sldId id="326" r:id="rId72"/>
    <p:sldId id="327" r:id="rId73"/>
    <p:sldId id="328" r:id="rId74"/>
    <p:sldId id="329" r:id="rId75"/>
    <p:sldId id="330" r:id="rId76"/>
    <p:sldId id="331" r:id="rId77"/>
    <p:sldId id="332" r:id="rId78"/>
    <p:sldId id="333" r:id="rId79"/>
    <p:sldId id="334" r:id="rId80"/>
    <p:sldId id="335" r:id="rId81"/>
    <p:sldId id="336" r:id="rId82"/>
    <p:sldId id="337" r:id="rId8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slide" Target="slides/slide62.xml"/><Relationship Id="rId68" Type="http://schemas.openxmlformats.org/officeDocument/2006/relationships/slide" Target="slides/slide67.xml"/><Relationship Id="rId76" Type="http://schemas.openxmlformats.org/officeDocument/2006/relationships/slide" Target="slides/slide75.xml"/><Relationship Id="rId84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71" Type="http://schemas.openxmlformats.org/officeDocument/2006/relationships/slide" Target="slides/slide70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74" Type="http://schemas.openxmlformats.org/officeDocument/2006/relationships/slide" Target="slides/slide73.xml"/><Relationship Id="rId79" Type="http://schemas.openxmlformats.org/officeDocument/2006/relationships/slide" Target="slides/slide78.xml"/><Relationship Id="rId87" Type="http://schemas.openxmlformats.org/officeDocument/2006/relationships/theme" Target="theme/theme1.xml"/><Relationship Id="rId5" Type="http://schemas.openxmlformats.org/officeDocument/2006/relationships/slide" Target="slides/slide4.xml"/><Relationship Id="rId61" Type="http://schemas.openxmlformats.org/officeDocument/2006/relationships/slide" Target="slides/slide60.xml"/><Relationship Id="rId82" Type="http://schemas.openxmlformats.org/officeDocument/2006/relationships/slide" Target="slides/slide81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slide" Target="slides/slide68.xml"/><Relationship Id="rId77" Type="http://schemas.openxmlformats.org/officeDocument/2006/relationships/slide" Target="slides/slide76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72" Type="http://schemas.openxmlformats.org/officeDocument/2006/relationships/slide" Target="slides/slide71.xml"/><Relationship Id="rId80" Type="http://schemas.openxmlformats.org/officeDocument/2006/relationships/slide" Target="slides/slide79.xml"/><Relationship Id="rId85" Type="http://schemas.openxmlformats.org/officeDocument/2006/relationships/presProps" Target="presProps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slide" Target="slides/slide69.xml"/><Relationship Id="rId75" Type="http://schemas.openxmlformats.org/officeDocument/2006/relationships/slide" Target="slides/slide74.xml"/><Relationship Id="rId83" Type="http://schemas.openxmlformats.org/officeDocument/2006/relationships/slide" Target="slides/slide82.xml"/><Relationship Id="rId8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73" Type="http://schemas.openxmlformats.org/officeDocument/2006/relationships/slide" Target="slides/slide72.xml"/><Relationship Id="rId78" Type="http://schemas.openxmlformats.org/officeDocument/2006/relationships/slide" Target="slides/slide77.xml"/><Relationship Id="rId81" Type="http://schemas.openxmlformats.org/officeDocument/2006/relationships/slide" Target="slides/slide80.xml"/><Relationship Id="rId86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B6B3A2-5C80-4B03-BD84-C48A31DD4C45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41DA29-42DA-44E6-BE56-1C954131BE2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264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2.xml"/><Relationship Id="rId1" Type="http://schemas.openxmlformats.org/officeDocument/2006/relationships/notesMaster" Target="../notesMasters/notesMaster1.xml"/></Relationships>
</file>

<file path=ppt/notesSlides/_rels/notesSlide4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4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4.xml"/><Relationship Id="rId1" Type="http://schemas.openxmlformats.org/officeDocument/2006/relationships/notesMaster" Target="../notesMasters/notesMaster1.xml"/></Relationships>
</file>

<file path=ppt/notesSlides/_rels/notesSlide4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4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4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7.xml"/><Relationship Id="rId1" Type="http://schemas.openxmlformats.org/officeDocument/2006/relationships/notesMaster" Target="../notesMasters/notesMaster1.xml"/></Relationships>
</file>

<file path=ppt/notesSlides/_rels/notesSlide4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8.xml"/><Relationship Id="rId1" Type="http://schemas.openxmlformats.org/officeDocument/2006/relationships/notesMaster" Target="../notesMasters/notesMaster1.xml"/></Relationships>
</file>

<file path=ppt/notesSlides/_rels/notesSlide4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9.xml"/><Relationship Id="rId1" Type="http://schemas.openxmlformats.org/officeDocument/2006/relationships/notesMaster" Target="../notesMasters/notesMaster1.xml"/></Relationships>
</file>

<file path=ppt/notesSlides/_rels/notesSlide4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0.xml"/><Relationship Id="rId1" Type="http://schemas.openxmlformats.org/officeDocument/2006/relationships/notesMaster" Target="../notesMasters/notesMaster1.xml"/></Relationships>
</file>

<file path=ppt/notesSlides/_rels/notesSlide4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1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2.xml"/><Relationship Id="rId1" Type="http://schemas.openxmlformats.org/officeDocument/2006/relationships/notesMaster" Target="../notesMasters/notesMaster1.xml"/></Relationships>
</file>

<file path=ppt/notesSlides/_rels/notesSlide5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3.xml"/><Relationship Id="rId1" Type="http://schemas.openxmlformats.org/officeDocument/2006/relationships/notesMaster" Target="../notesMasters/notesMaster1.xml"/></Relationships>
</file>

<file path=ppt/notesSlides/_rels/notesSlide5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4.xml"/><Relationship Id="rId1" Type="http://schemas.openxmlformats.org/officeDocument/2006/relationships/notesMaster" Target="../notesMasters/notesMaster1.xml"/></Relationships>
</file>

<file path=ppt/notesSlides/_rels/notesSlide5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5.xml"/><Relationship Id="rId1" Type="http://schemas.openxmlformats.org/officeDocument/2006/relationships/notesMaster" Target="../notesMasters/notesMaster1.xml"/></Relationships>
</file>

<file path=ppt/notesSlides/_rels/notesSlide5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6.xml"/><Relationship Id="rId1" Type="http://schemas.openxmlformats.org/officeDocument/2006/relationships/notesMaster" Target="../notesMasters/notesMaster1.xml"/></Relationships>
</file>

<file path=ppt/notesSlides/_rels/notesSlide5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7.xml"/><Relationship Id="rId1" Type="http://schemas.openxmlformats.org/officeDocument/2006/relationships/notesMaster" Target="../notesMasters/notesMaster1.xml"/></Relationships>
</file>

<file path=ppt/notesSlides/_rels/notesSlide5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9.xml"/><Relationship Id="rId1" Type="http://schemas.openxmlformats.org/officeDocument/2006/relationships/notesMaster" Target="../notesMasters/notesMaster1.xml"/></Relationships>
</file>

<file path=ppt/notesSlides/_rels/notesSlide5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0.xml"/><Relationship Id="rId1" Type="http://schemas.openxmlformats.org/officeDocument/2006/relationships/notesMaster" Target="../notesMasters/notesMaster1.xml"/></Relationships>
</file>

<file path=ppt/notesSlides/_rels/notesSlide5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1.xml"/><Relationship Id="rId1" Type="http://schemas.openxmlformats.org/officeDocument/2006/relationships/notesMaster" Target="../notesMasters/notesMaster1.xml"/></Relationships>
</file>

<file path=ppt/notesSlides/_rels/notesSlide5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2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3.xml"/><Relationship Id="rId1" Type="http://schemas.openxmlformats.org/officeDocument/2006/relationships/notesMaster" Target="../notesMasters/notesMaster1.xml"/></Relationships>
</file>

<file path=ppt/notesSlides/_rels/notesSlide6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4.xml"/><Relationship Id="rId1" Type="http://schemas.openxmlformats.org/officeDocument/2006/relationships/notesMaster" Target="../notesMasters/notesMaster1.xml"/></Relationships>
</file>

<file path=ppt/notesSlides/_rels/notesSlide6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5.xml"/><Relationship Id="rId1" Type="http://schemas.openxmlformats.org/officeDocument/2006/relationships/notesMaster" Target="../notesMasters/notesMaster1.xml"/></Relationships>
</file>

<file path=ppt/notesSlides/_rels/notesSlide6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6.xml"/><Relationship Id="rId1" Type="http://schemas.openxmlformats.org/officeDocument/2006/relationships/notesMaster" Target="../notesMasters/notesMaster1.xml"/></Relationships>
</file>

<file path=ppt/notesSlides/_rels/notesSlide6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7.xml"/><Relationship Id="rId1" Type="http://schemas.openxmlformats.org/officeDocument/2006/relationships/notesMaster" Target="../notesMasters/notesMaster1.xml"/></Relationships>
</file>

<file path=ppt/notesSlides/_rels/notesSlide6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8.xml"/><Relationship Id="rId1" Type="http://schemas.openxmlformats.org/officeDocument/2006/relationships/notesMaster" Target="../notesMasters/notesMaster1.xml"/></Relationships>
</file>

<file path=ppt/notesSlides/_rels/notesSlide6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9.xml"/><Relationship Id="rId1" Type="http://schemas.openxmlformats.org/officeDocument/2006/relationships/notesMaster" Target="../notesMasters/notesMaster1.xml"/></Relationships>
</file>

<file path=ppt/notesSlides/_rels/notesSlide6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0.xml"/><Relationship Id="rId1" Type="http://schemas.openxmlformats.org/officeDocument/2006/relationships/notesMaster" Target="../notesMasters/notesMaster1.xml"/></Relationships>
</file>

<file path=ppt/notesSlides/_rels/notesSlide6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1.xml"/><Relationship Id="rId1" Type="http://schemas.openxmlformats.org/officeDocument/2006/relationships/notesMaster" Target="../notesMasters/notesMaster1.xml"/></Relationships>
</file>

<file path=ppt/notesSlides/_rels/notesSlide6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2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3.xml"/><Relationship Id="rId1" Type="http://schemas.openxmlformats.org/officeDocument/2006/relationships/notesMaster" Target="../notesMasters/notesMaster1.xml"/></Relationships>
</file>

<file path=ppt/notesSlides/_rels/notesSlide7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4.xml"/><Relationship Id="rId1" Type="http://schemas.openxmlformats.org/officeDocument/2006/relationships/notesMaster" Target="../notesMasters/notesMaster1.xml"/></Relationships>
</file>

<file path=ppt/notesSlides/_rels/notesSlide7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5.xml"/><Relationship Id="rId1" Type="http://schemas.openxmlformats.org/officeDocument/2006/relationships/notesMaster" Target="../notesMasters/notesMaster1.xml"/></Relationships>
</file>

<file path=ppt/notesSlides/_rels/notesSlide7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6.xml"/><Relationship Id="rId1" Type="http://schemas.openxmlformats.org/officeDocument/2006/relationships/notesMaster" Target="../notesMasters/notesMaster1.xml"/></Relationships>
</file>

<file path=ppt/notesSlides/_rels/notesSlide7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7.xml"/><Relationship Id="rId1" Type="http://schemas.openxmlformats.org/officeDocument/2006/relationships/notesMaster" Target="../notesMasters/notesMaster1.xml"/></Relationships>
</file>

<file path=ppt/notesSlides/_rels/notesSlide7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8.xml"/><Relationship Id="rId1" Type="http://schemas.openxmlformats.org/officeDocument/2006/relationships/notesMaster" Target="../notesMasters/notesMaster1.xml"/></Relationships>
</file>

<file path=ppt/notesSlides/_rels/notesSlide7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9.xml"/><Relationship Id="rId1" Type="http://schemas.openxmlformats.org/officeDocument/2006/relationships/notesMaster" Target="../notesMasters/notesMaster1.xml"/></Relationships>
</file>

<file path=ppt/notesSlides/_rels/notesSlide7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0.xml"/><Relationship Id="rId1" Type="http://schemas.openxmlformats.org/officeDocument/2006/relationships/notesMaster" Target="../notesMasters/notesMaster1.xml"/></Relationships>
</file>

<file path=ppt/notesSlides/_rels/notesSlide7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1.xml"/><Relationship Id="rId1" Type="http://schemas.openxmlformats.org/officeDocument/2006/relationships/notesMaster" Target="../notesMasters/notesMaster1.xml"/></Relationships>
</file>

<file path=ppt/notesSlides/_rels/notesSlide7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2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p 1 (Mediterranean) gave rise to Pop 3 (NE Atlantic), which then gave rise to Pop 4 (NW Atlantic).  Pop 1 (Mediterranean) also gave rise to Pop 2 (Pacific).</a:t>
            </a: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0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ave rise to Pop 2 (Pacific), which then gave rise to Pop 3 (NE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4 (NW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1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p 1 (Mediterranean)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2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3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 smtClean="0"/>
          </a:p>
          <a:p>
            <a:r>
              <a:rPr lang="en-US" dirty="0" smtClean="0"/>
              <a:t>Pop 2 (Pacific)</a:t>
            </a:r>
            <a:r>
              <a:rPr lang="en-US" baseline="0" dirty="0" smtClean="0"/>
              <a:t> gave rise to Pop 1 (Mediterranean), and also gave rise to Pop 3 (NE Atlantic), which gave rise to Pop 4 (NW Atlantic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4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r>
              <a:rPr lang="en-US" dirty="0" smtClean="0"/>
              <a:t>Pop 3 (NE Atlantic)</a:t>
            </a:r>
            <a:r>
              <a:rPr lang="en-US" baseline="0" dirty="0" smtClean="0"/>
              <a:t> gave rise to Pop 2 (Pacific), which gave rise to Pop 1 (Mediterranean).  Pop 3 (NE Atlantic) gave rise to Pop 4 (NW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5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r>
              <a:rPr lang="en-US" dirty="0" smtClean="0"/>
              <a:t>Pop 4 (NW Atlantic)</a:t>
            </a:r>
            <a:r>
              <a:rPr lang="en-US" baseline="0" dirty="0" smtClean="0"/>
              <a:t> gave rise to Pop 2 (Pacific), which gave rise to Pop 1 (Mediterranean).  Pop 4 (NW Atlantic) also gave rise to Pop 3 (NE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6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r>
              <a:rPr lang="en-US" baseline="0" dirty="0" smtClean="0"/>
              <a:t>Pop 2 (Pacific) gave rise to Pop 4 (NW Atlantic), which gave rise to Pop 1 (Mediterranean) then to Pop 3 (NE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7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r>
              <a:rPr lang="en-US" baseline="0" dirty="0" err="1" smtClean="0"/>
              <a:t>Unsampled</a:t>
            </a:r>
            <a:r>
              <a:rPr lang="en-US" baseline="0" dirty="0" smtClean="0"/>
              <a:t> population gave rise to Pop 4 (NW Atlantic), which gave rise to Pop 1 (Mediterranean) then to Pop 3 (NE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8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Pop 2 (Pacific) gave rise to Pop 4 (NW Atlantic) which gave rise to Pop 3 (NE Atlantic) and then to Pop 1 (Mediterranean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19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err="1" smtClean="0"/>
              <a:t>Unsampled</a:t>
            </a:r>
            <a:r>
              <a:rPr lang="en-US" baseline="0" dirty="0" smtClean="0"/>
              <a:t> population gave rise to Pop 4 (NW Atlantic) which gave rise to Pop 3 (NE Atlantic) and then to Pop 1 (Mediterranean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p 1 (Mediterranean) gave rise to Pop 4 (NW Atlantic), which then gave rise to Pop 3 (NE Atlantic).  Pop 1 (Mediterranean) also gave rise to Pop 2 (Pacific).</a:t>
            </a: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0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Pop 2 (Pacific) gave rise to Pop 3 (NE Atlantic) which gave rise to Pop 4 (NW Atlantic) and then to Pop 1 (Mediterranean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1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err="1" smtClean="0"/>
              <a:t>Unsampled</a:t>
            </a:r>
            <a:r>
              <a:rPr lang="en-US" baseline="0" dirty="0" smtClean="0"/>
              <a:t> population gave rise to Pop 3 (NE Atlantic) which gave rise to Pop 4 (NW Atlantic) and then to Pop 1 (Mediterranean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2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Pop 2 (Pacific) gave rise to Pop 3 (NE Atlantic) which gave rise to Pop 1 (Mediterranean) and then to Pop 4 (NW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3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err="1" smtClean="0"/>
              <a:t>Unsampled</a:t>
            </a:r>
            <a:r>
              <a:rPr lang="en-US" baseline="0" dirty="0" smtClean="0"/>
              <a:t> population gave rise to Pop 3 (NE Atlantic) which gave rise to Pop 1 (Mediterranean) and then to Pop 4 (NW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4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Pop 2 (Pacific) gave rise to Pop 1 (Mediterranean) which gave rise to Pop 3 (NE Atlantic) and then to Pop 4 (NW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5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err="1" smtClean="0"/>
              <a:t>Unsampled</a:t>
            </a:r>
            <a:r>
              <a:rPr lang="en-US" baseline="0" dirty="0" smtClean="0"/>
              <a:t> population gave rise to Pop 1 (Mediterranean) which gave rise to Pop 3 (NE Atlantic) and then to Pop 4 (NW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6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Pop 2 (Pacific) gave rise to Pop 1 (Mediterranean) which gave rise to Pop 4 (NW Atlantic) and then to Pop 3 (NE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7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err="1" smtClean="0"/>
              <a:t>Unsampled</a:t>
            </a:r>
            <a:r>
              <a:rPr lang="en-US" baseline="0" dirty="0" smtClean="0"/>
              <a:t> population gave rise to Pop 1 (Mediterranean) which gave rise to Pop 4 (NW Atlantic) and then to Pop 3 (NE Atlantic)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8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491590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29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4915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p 1 (Mediterranean) gave rise to Pop 4 (NW Atlantic), which then gave rise to Pop 2 (Pacif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0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491590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1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2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3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4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5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6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7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8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39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ave rise to Pop 4 (NW Atlantic), which then gave rise to Pop 2 (Pacif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0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1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2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491590"/>
      </p:ext>
    </p:extLst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3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491590"/>
      </p:ext>
    </p:extLst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4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491590"/>
      </p:ext>
    </p:extLst>
  </p:cSld>
  <p:clrMapOvr>
    <a:masterClrMapping/>
  </p:clrMapOvr>
</p:notes>
</file>

<file path=ppt/notesSlides/notesSlide4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5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4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6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4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7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4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4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8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4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49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5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4 (NW Atlantic), which then gave rise to Pop 3 (NE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2 (Pacif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50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51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52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53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54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55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2 (Pacif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3 (NE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5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2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3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5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4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6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3 (NE Atlantic), which then gave rise to Pop 2 (Pacif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4 (NW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5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6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7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8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9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0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1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6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2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3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6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4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7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p 1 (Mediterranean) gave rise to Pop 3 (NE Atlant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2 (Pacif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7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5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7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6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7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7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491590"/>
      </p:ext>
    </p:extLst>
  </p:cSld>
  <p:clrMapOvr>
    <a:masterClrMapping/>
  </p:clrMapOvr>
</p:notes>
</file>

<file path=ppt/notesSlides/notesSlide7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8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491590"/>
      </p:ext>
    </p:extLst>
  </p:cSld>
  <p:clrMapOvr>
    <a:masterClrMapping/>
  </p:clrMapOvr>
</p:notes>
</file>

<file path=ppt/notesSlides/notesSlide7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19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7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20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7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21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7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7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22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8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7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cenario 23: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8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7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mtClean="0"/>
              <a:t>Scenario 24:</a:t>
            </a:r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y of Biscay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= Green (3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Purple (1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glish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hannel France = Blue (4), English Channel England = Orange (2)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8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8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gave rise to Pop 3 (NE Atlantic), which then gave rise to Pop 4 (NW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2 (Pacif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enario 9: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 Atlanti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 Green, Mediterranean = Purple, NW Atlantic = Blue, Pacific = Orange,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Red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diterranean = 1, Pacific = 2, NE Atlantic = 3, NW Atlantic = 4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sampl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opulation = 5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op 1 (Mediterranean) gave rise to Pop 2 (Pacific), which then gave rise to Pop 3 (NE Atlantic),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then to Pop 4 (NW Atlantic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57B15AE-0D81-4355-9EC3-D8FF17E41391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9032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7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8.xml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9.xml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0.xml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1.xml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2.xml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3.xml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4.xml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5.xml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6.xml"/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7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8.xml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9.xml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0.xml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1.xml"/><Relationship Id="rId1" Type="http://schemas.openxmlformats.org/officeDocument/2006/relationships/slideLayout" Target="../slideLayouts/slideLayout7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2.xml"/><Relationship Id="rId1" Type="http://schemas.openxmlformats.org/officeDocument/2006/relationships/slideLayout" Target="../slideLayouts/slideLayout7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3.xml"/><Relationship Id="rId1" Type="http://schemas.openxmlformats.org/officeDocument/2006/relationships/slideLayout" Target="../slideLayouts/slideLayout7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4.xml"/><Relationship Id="rId1" Type="http://schemas.openxmlformats.org/officeDocument/2006/relationships/slideLayout" Target="../slideLayouts/slideLayout7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5.xml"/><Relationship Id="rId1" Type="http://schemas.openxmlformats.org/officeDocument/2006/relationships/slideLayout" Target="../slideLayouts/slideLayout7.xml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6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7.xml"/><Relationship Id="rId1" Type="http://schemas.openxmlformats.org/officeDocument/2006/relationships/slideLayout" Target="../slideLayouts/slideLayout7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8.xml"/><Relationship Id="rId1" Type="http://schemas.openxmlformats.org/officeDocument/2006/relationships/slideLayout" Target="../slideLayouts/slideLayout7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9.xml"/><Relationship Id="rId1" Type="http://schemas.openxmlformats.org/officeDocument/2006/relationships/slideLayout" Target="../slideLayouts/slideLayout7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0.xml"/><Relationship Id="rId1" Type="http://schemas.openxmlformats.org/officeDocument/2006/relationships/slideLayout" Target="../slideLayouts/slideLayout7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1.xml"/><Relationship Id="rId1" Type="http://schemas.openxmlformats.org/officeDocument/2006/relationships/slideLayout" Target="../slideLayouts/slideLayout7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2.xml"/><Relationship Id="rId1" Type="http://schemas.openxmlformats.org/officeDocument/2006/relationships/slideLayout" Target="../slideLayouts/slideLayout7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3.xml"/><Relationship Id="rId1" Type="http://schemas.openxmlformats.org/officeDocument/2006/relationships/slideLayout" Target="../slideLayouts/slideLayout7.xml"/></Relationships>
</file>

<file path=ppt/slides/_rels/slide6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4.xml"/><Relationship Id="rId1" Type="http://schemas.openxmlformats.org/officeDocument/2006/relationships/slideLayout" Target="../slideLayouts/slideLayout7.xml"/></Relationships>
</file>

<file path=ppt/slides/_rels/slide6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5.xml"/><Relationship Id="rId1" Type="http://schemas.openxmlformats.org/officeDocument/2006/relationships/slideLayout" Target="../slideLayouts/slideLayout7.xml"/></Relationships>
</file>

<file path=ppt/slides/_rels/slide6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7.xml"/><Relationship Id="rId1" Type="http://schemas.openxmlformats.org/officeDocument/2006/relationships/slideLayout" Target="../slideLayouts/slideLayout7.xml"/></Relationships>
</file>

<file path=ppt/slides/_rels/slide7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8.xml"/><Relationship Id="rId1" Type="http://schemas.openxmlformats.org/officeDocument/2006/relationships/slideLayout" Target="../slideLayouts/slideLayout7.xml"/></Relationships>
</file>

<file path=ppt/slides/_rels/slide7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9.xml"/><Relationship Id="rId1" Type="http://schemas.openxmlformats.org/officeDocument/2006/relationships/slideLayout" Target="../slideLayouts/slideLayout7.xml"/></Relationships>
</file>

<file path=ppt/slides/_rels/slide7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0.xml"/><Relationship Id="rId1" Type="http://schemas.openxmlformats.org/officeDocument/2006/relationships/slideLayout" Target="../slideLayouts/slideLayout7.xml"/></Relationships>
</file>

<file path=ppt/slides/_rels/slide7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1.xml"/><Relationship Id="rId1" Type="http://schemas.openxmlformats.org/officeDocument/2006/relationships/slideLayout" Target="../slideLayouts/slideLayout7.xml"/></Relationships>
</file>

<file path=ppt/slides/_rels/slide7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2.xml"/><Relationship Id="rId1" Type="http://schemas.openxmlformats.org/officeDocument/2006/relationships/slideLayout" Target="../slideLayouts/slideLayout7.xml"/></Relationships>
</file>

<file path=ppt/slides/_rels/slide7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3.xml"/><Relationship Id="rId1" Type="http://schemas.openxmlformats.org/officeDocument/2006/relationships/slideLayout" Target="../slideLayouts/slideLayout7.xml"/></Relationships>
</file>

<file path=ppt/slides/_rels/slide7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4.xml"/><Relationship Id="rId1" Type="http://schemas.openxmlformats.org/officeDocument/2006/relationships/slideLayout" Target="../slideLayouts/slideLayout7.xml"/></Relationships>
</file>

<file path=ppt/slides/_rels/slide7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5.xml"/><Relationship Id="rId1" Type="http://schemas.openxmlformats.org/officeDocument/2006/relationships/slideLayout" Target="../slideLayouts/slideLayout7.xml"/></Relationships>
</file>

<file path=ppt/slides/_rels/slide7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7.xml"/><Relationship Id="rId1" Type="http://schemas.openxmlformats.org/officeDocument/2006/relationships/slideLayout" Target="../slideLayouts/slideLayout7.xml"/></Relationships>
</file>

<file path=ppt/slides/_rels/slide8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8.xml"/><Relationship Id="rId1" Type="http://schemas.openxmlformats.org/officeDocument/2006/relationships/slideLayout" Target="../slideLayouts/slideLayout7.xml"/></Relationships>
</file>

<file path=ppt/slides/_rels/slide8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9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7200" y="381000"/>
            <a:ext cx="8382000" cy="5943600"/>
          </a:xfrm>
        </p:spPr>
        <p:txBody>
          <a:bodyPr>
            <a:normAutofit/>
          </a:bodyPr>
          <a:lstStyle/>
          <a:p>
            <a:r>
              <a:rPr lang="en-US" sz="1800" dirty="0" smtClean="0"/>
              <a:t>Supporting Information Table </a:t>
            </a:r>
            <a:r>
              <a:rPr lang="en-US" sz="1800" dirty="0" smtClean="0"/>
              <a:t>3:</a:t>
            </a:r>
            <a:br>
              <a:rPr lang="en-US" sz="1800" dirty="0" smtClean="0"/>
            </a:br>
            <a:r>
              <a:rPr lang="en-US" sz="1800" dirty="0"/>
              <a:t>Visualizations of Clade A and Clade E DIYABC scenarios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endParaRPr 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3358344" y="2343834"/>
            <a:ext cx="837083" cy="207576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517491" y="3239177"/>
            <a:ext cx="344930" cy="1180423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4711578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905252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207501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195427" y="2343834"/>
            <a:ext cx="322064" cy="93276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1917" y="1752600"/>
            <a:ext cx="302274" cy="603703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56095" y="3276600"/>
            <a:ext cx="461396" cy="1133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11622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379333" y="3034070"/>
            <a:ext cx="631593" cy="137612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98584" y="1762836"/>
            <a:ext cx="480749" cy="132909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8100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2004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860083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3358344" y="2435274"/>
            <a:ext cx="762769" cy="198432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3962400" y="3006747"/>
            <a:ext cx="434904" cy="1412853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428083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379333" y="3034070"/>
            <a:ext cx="480750" cy="138553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121113" y="2435274"/>
            <a:ext cx="258220" cy="6566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4003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207501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709240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3358344" y="2435274"/>
            <a:ext cx="762769" cy="198432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1917" y="1752600"/>
            <a:ext cx="229196" cy="682674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95359" y="3091934"/>
            <a:ext cx="283974" cy="132766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70267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3509187" y="2635773"/>
            <a:ext cx="663498" cy="177442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98584" y="1762836"/>
            <a:ext cx="597216" cy="1760147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91779" y="453342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558397" y="45486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509564" y="3488604"/>
            <a:ext cx="350519" cy="92159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172685" y="3460550"/>
            <a:ext cx="336879" cy="949644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4363520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3509187" y="2635773"/>
            <a:ext cx="663498" cy="177442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172685" y="2635773"/>
            <a:ext cx="266139" cy="667643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709240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438824" y="3303416"/>
            <a:ext cx="421259" cy="110677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4904609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/>
          <p:cNvCxnSpPr/>
          <p:nvPr/>
        </p:nvCxnSpPr>
        <p:spPr>
          <a:xfrm>
            <a:off x="3847757" y="1797427"/>
            <a:ext cx="762343" cy="130688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598380" y="3092042"/>
            <a:ext cx="565727" cy="132755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352800" y="1758542"/>
            <a:ext cx="494960" cy="144185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686565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53940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2819400" y="3200400"/>
            <a:ext cx="515390" cy="12192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4257675" y="3076694"/>
            <a:ext cx="333596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847756" y="1429881"/>
            <a:ext cx="1" cy="36754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352800" y="3124200"/>
            <a:ext cx="337450" cy="125540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886386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/>
          <p:cNvCxnSpPr/>
          <p:nvPr/>
        </p:nvCxnSpPr>
        <p:spPr>
          <a:xfrm>
            <a:off x="3847757" y="1797427"/>
            <a:ext cx="762343" cy="130688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598380" y="3092042"/>
            <a:ext cx="565727" cy="132755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352800" y="1758542"/>
            <a:ext cx="494958" cy="151805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635470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45237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2837408" y="3276600"/>
            <a:ext cx="515392" cy="11430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4257675" y="3076694"/>
            <a:ext cx="333596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847757" y="1403420"/>
            <a:ext cx="0" cy="394007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352800" y="3200400"/>
            <a:ext cx="269470" cy="12192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806495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858072" y="1752600"/>
            <a:ext cx="790128" cy="1524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276600" y="1758542"/>
            <a:ext cx="571158" cy="144185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389204" y="457557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533689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862421" y="460605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168152" y="457557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2743200" y="3200400"/>
            <a:ext cx="533400" cy="12192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664874" y="3273922"/>
            <a:ext cx="348390" cy="114567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858652" y="1389703"/>
            <a:ext cx="0" cy="356462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276600" y="3124200"/>
            <a:ext cx="361778" cy="12954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321956" y="3273922"/>
            <a:ext cx="295765" cy="114567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1841950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858072" y="1752600"/>
            <a:ext cx="658175" cy="135171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39522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3546071" y="2514600"/>
            <a:ext cx="641088" cy="193548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516247" y="3091934"/>
            <a:ext cx="647860" cy="132766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3847756" y="1476494"/>
            <a:ext cx="0" cy="28204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273630" y="3079911"/>
            <a:ext cx="208520" cy="1370169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3346842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4273630" y="2514600"/>
            <a:ext cx="900792" cy="186017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39522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3546071" y="2514600"/>
            <a:ext cx="711604" cy="193548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4257675" y="3091934"/>
            <a:ext cx="258572" cy="132766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3847756" y="1476494"/>
            <a:ext cx="0" cy="28204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831390" y="1773782"/>
            <a:ext cx="426285" cy="74081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52486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All Clade A Scenarios tested in DIYABC.  Scenarios 1-12 are Mediterranean ancestral, Scenarios 13, 16-27 are Pacific ancestral, Scenarios 14, 28-41 are northeastern Atlantic ancestral, and Scenarios 15, 42-55 are northwestern Atlantic ancestral.</a:t>
            </a:r>
            <a:endParaRPr lang="en-US" dirty="0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858072" y="1752600"/>
            <a:ext cx="1316350" cy="262217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155695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9522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4273631" y="3104311"/>
            <a:ext cx="260584" cy="1270462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3546070" y="2450485"/>
            <a:ext cx="614475" cy="1999595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4809633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4160545" y="2450485"/>
            <a:ext cx="1013877" cy="192428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155695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9522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4273631" y="3104311"/>
            <a:ext cx="260584" cy="1270462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3546070" y="2450485"/>
            <a:ext cx="614475" cy="1999595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841521" y="1752600"/>
            <a:ext cx="314174" cy="697885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101765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 flipH="1">
            <a:off x="3546070" y="2372528"/>
            <a:ext cx="574103" cy="2047072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155695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6249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4273631" y="3104311"/>
            <a:ext cx="260584" cy="1270462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847756" y="1815254"/>
            <a:ext cx="1316351" cy="260434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2820868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 flipH="1">
            <a:off x="3546070" y="2372528"/>
            <a:ext cx="574103" cy="2047072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862421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37551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6249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4642140" y="3396064"/>
            <a:ext cx="371124" cy="10540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120173" y="2372528"/>
            <a:ext cx="521967" cy="102353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833121" y="1768825"/>
            <a:ext cx="287052" cy="603703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313223" y="3396064"/>
            <a:ext cx="328917" cy="102353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7059899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4563107" y="3307080"/>
            <a:ext cx="570519" cy="1143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36249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17406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982783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3513337" y="2357288"/>
            <a:ext cx="581900" cy="2062312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847756" y="1815254"/>
            <a:ext cx="745832" cy="157319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306538" y="3323700"/>
            <a:ext cx="260095" cy="112638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182664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4593588" y="3276600"/>
            <a:ext cx="570519" cy="1143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36249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89182" y="45809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59081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3513337" y="2357288"/>
            <a:ext cx="581900" cy="2062312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095237" y="2357288"/>
            <a:ext cx="534435" cy="103115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823981" y="1758542"/>
            <a:ext cx="271256" cy="603703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362454" y="3310205"/>
            <a:ext cx="256828" cy="1139875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136142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4593588" y="3276600"/>
            <a:ext cx="570519" cy="12192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05822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6249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3855024" y="1759389"/>
            <a:ext cx="738564" cy="151721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3505200" y="2438400"/>
            <a:ext cx="685801" cy="20574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191001" y="3258234"/>
            <a:ext cx="402587" cy="123756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909276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4442745" y="3276600"/>
            <a:ext cx="434055" cy="117348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97891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6249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72595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4155695" y="2514600"/>
            <a:ext cx="301686" cy="7620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3513337" y="2514600"/>
            <a:ext cx="642358" cy="193548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834516" y="1758542"/>
            <a:ext cx="321179" cy="75605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129755" y="3276600"/>
            <a:ext cx="312990" cy="119634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4543244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 flipH="1">
            <a:off x="3664180" y="2666999"/>
            <a:ext cx="618243" cy="175260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276600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48967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170295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03120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3855024" y="1759389"/>
            <a:ext cx="815130" cy="169247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670155" y="3451860"/>
            <a:ext cx="493952" cy="96774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321140" y="3451860"/>
            <a:ext cx="349014" cy="99822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96176281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 flipH="1">
            <a:off x="3664180" y="2666999"/>
            <a:ext cx="618243" cy="175260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358633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457980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282406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03120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4282423" y="2666999"/>
            <a:ext cx="440842" cy="8763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723265" y="3543299"/>
            <a:ext cx="440842" cy="906781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804806" y="1758542"/>
            <a:ext cx="477617" cy="908457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471981" y="3543299"/>
            <a:ext cx="248649" cy="90678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503267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/>
          <p:cNvCxnSpPr/>
          <p:nvPr/>
        </p:nvCxnSpPr>
        <p:spPr>
          <a:xfrm>
            <a:off x="3905251" y="1758542"/>
            <a:ext cx="704849" cy="134576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598380" y="3092042"/>
            <a:ext cx="565727" cy="132755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4" y="2876788"/>
            <a:ext cx="621381" cy="1573292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546070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358344" y="2897678"/>
            <a:ext cx="338569" cy="1552402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4257675" y="3076694"/>
            <a:ext cx="333596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3074023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/>
          <p:cNvCxnSpPr/>
          <p:nvPr/>
        </p:nvCxnSpPr>
        <p:spPr>
          <a:xfrm>
            <a:off x="3847757" y="1797427"/>
            <a:ext cx="762343" cy="130688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>
            <a:off x="4598380" y="3092042"/>
            <a:ext cx="565727" cy="132755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2635470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45237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3" name="Straight Connector 12"/>
          <p:cNvCxnSpPr/>
          <p:nvPr/>
        </p:nvCxnSpPr>
        <p:spPr>
          <a:xfrm flipH="1">
            <a:off x="2837408" y="1797427"/>
            <a:ext cx="1010349" cy="2622173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>
            <a:off x="4257675" y="3076694"/>
            <a:ext cx="333596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7757" y="1403420"/>
            <a:ext cx="0" cy="394007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352800" y="3124200"/>
            <a:ext cx="269470" cy="12954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2261163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/>
          <p:cNvCxnSpPr/>
          <p:nvPr/>
        </p:nvCxnSpPr>
        <p:spPr>
          <a:xfrm>
            <a:off x="3847757" y="1797427"/>
            <a:ext cx="762343" cy="130688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>
            <a:off x="4598380" y="3092042"/>
            <a:ext cx="565727" cy="132755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3283170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605595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4" name="Straight Connector 13"/>
          <p:cNvCxnSpPr/>
          <p:nvPr/>
        </p:nvCxnSpPr>
        <p:spPr>
          <a:xfrm flipH="1">
            <a:off x="4257675" y="3076694"/>
            <a:ext cx="333596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7757" y="1403420"/>
            <a:ext cx="0" cy="394007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2786313" y="3124200"/>
            <a:ext cx="490287" cy="13182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276600" y="3124200"/>
            <a:ext cx="183485" cy="12954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flipH="1">
            <a:off x="3276600" y="1752600"/>
            <a:ext cx="566488" cy="14478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51708950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Straight Connector 1"/>
          <p:cNvCxnSpPr/>
          <p:nvPr/>
        </p:nvCxnSpPr>
        <p:spPr>
          <a:xfrm>
            <a:off x="3847757" y="1797427"/>
            <a:ext cx="762343" cy="130688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Straight Connector 2"/>
          <p:cNvCxnSpPr/>
          <p:nvPr/>
        </p:nvCxnSpPr>
        <p:spPr>
          <a:xfrm>
            <a:off x="4598380" y="3092042"/>
            <a:ext cx="565727" cy="132755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3283170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605595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4" name="Straight Connector 13"/>
          <p:cNvCxnSpPr/>
          <p:nvPr/>
        </p:nvCxnSpPr>
        <p:spPr>
          <a:xfrm flipH="1">
            <a:off x="4257675" y="3076694"/>
            <a:ext cx="333596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7757" y="1403420"/>
            <a:ext cx="0" cy="394007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2786314" y="3276600"/>
            <a:ext cx="490286" cy="11658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276600" y="3200400"/>
            <a:ext cx="183485" cy="12192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H="1">
            <a:off x="3276600" y="1797427"/>
            <a:ext cx="571158" cy="1479173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6279012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38824" y="3275884"/>
            <a:ext cx="342900" cy="113431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3509187" y="2635773"/>
            <a:ext cx="663498" cy="177442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172685" y="2635773"/>
            <a:ext cx="266139" cy="667643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531980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44586296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38824" y="3275884"/>
            <a:ext cx="342900" cy="113431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4085922" y="3334270"/>
            <a:ext cx="379443" cy="108533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172685" y="2635773"/>
            <a:ext cx="266139" cy="667643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41803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531980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951773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3603748" y="2666999"/>
            <a:ext cx="568937" cy="1752601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265081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568875" y="2708729"/>
            <a:ext cx="603810" cy="1701465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4085923" y="3460550"/>
            <a:ext cx="379442" cy="95905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41803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531980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951773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5612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172685" y="2693489"/>
            <a:ext cx="590492" cy="1726111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1775987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172685" y="2708729"/>
            <a:ext cx="741335" cy="171087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4085922" y="3334270"/>
            <a:ext cx="379443" cy="108533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41803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531980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951773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3603748" y="2666999"/>
            <a:ext cx="568937" cy="1752601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691558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38824" y="3275884"/>
            <a:ext cx="342900" cy="113431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3509187" y="2635773"/>
            <a:ext cx="677764" cy="177442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81227" y="1752600"/>
            <a:ext cx="557597" cy="155081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7908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48945431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452905" y="2708729"/>
            <a:ext cx="768620" cy="171087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427155" y="3303416"/>
            <a:ext cx="354569" cy="111618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81227" y="1752600"/>
            <a:ext cx="557597" cy="155081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29132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7908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60443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14356747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38824" y="3275884"/>
            <a:ext cx="342900" cy="113431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81227" y="1752600"/>
            <a:ext cx="557597" cy="155081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7908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3452905" y="2543247"/>
            <a:ext cx="720295" cy="187635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143567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200400" y="1752600"/>
            <a:ext cx="704852" cy="16002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905252" y="1752600"/>
            <a:ext cx="742948" cy="16002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6" y="3276600"/>
            <a:ext cx="463434" cy="12192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546070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29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1910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200400" y="3352800"/>
            <a:ext cx="496513" cy="109728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648200" y="3352800"/>
            <a:ext cx="504604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191000" y="3200400"/>
            <a:ext cx="381000" cy="12954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56615143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173200" y="2666999"/>
            <a:ext cx="608524" cy="1743195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81227" y="1752600"/>
            <a:ext cx="291973" cy="914399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7908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3452905" y="2543247"/>
            <a:ext cx="720295" cy="187635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12687131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24426" y="3303416"/>
            <a:ext cx="357298" cy="110677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81227" y="1752600"/>
            <a:ext cx="291973" cy="914399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7908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3452906" y="2600606"/>
            <a:ext cx="704023" cy="181899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4156929" y="2600606"/>
            <a:ext cx="267497" cy="70281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41417975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3881227" y="1752600"/>
            <a:ext cx="900497" cy="265759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7908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3452905" y="2591200"/>
            <a:ext cx="704023" cy="181899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819788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3881227" y="1752600"/>
            <a:ext cx="900497" cy="265759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47908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88122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891917" y="1199211"/>
            <a:ext cx="0" cy="55338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3452905" y="2528008"/>
            <a:ext cx="651426" cy="1811559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2780773" y="1752600"/>
            <a:ext cx="1100454" cy="26575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4085922" y="3197468"/>
            <a:ext cx="285110" cy="121272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57034127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/>
          <p:cNvCxnSpPr/>
          <p:nvPr/>
        </p:nvCxnSpPr>
        <p:spPr>
          <a:xfrm>
            <a:off x="3847757" y="1253782"/>
            <a:ext cx="0" cy="543645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2635470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45237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013264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105202" y="461950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3" name="Straight Connector 12"/>
          <p:cNvCxnSpPr/>
          <p:nvPr/>
        </p:nvCxnSpPr>
        <p:spPr>
          <a:xfrm flipH="1">
            <a:off x="2837408" y="1797427"/>
            <a:ext cx="1010349" cy="2622173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591271" y="3076694"/>
            <a:ext cx="572836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352800" y="3048000"/>
            <a:ext cx="269470" cy="13716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3900754" y="1800189"/>
            <a:ext cx="690517" cy="130832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246012" y="3076694"/>
            <a:ext cx="299092" cy="134290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8229494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/>
          <p:cNvCxnSpPr/>
          <p:nvPr/>
        </p:nvCxnSpPr>
        <p:spPr>
          <a:xfrm flipH="1">
            <a:off x="4210271" y="3084368"/>
            <a:ext cx="381000" cy="132755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3283170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605595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862421" y="462129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046662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3" name="Straight Connector 12"/>
          <p:cNvCxnSpPr/>
          <p:nvPr/>
        </p:nvCxnSpPr>
        <p:spPr>
          <a:xfrm flipH="1">
            <a:off x="3276600" y="1797427"/>
            <a:ext cx="571159" cy="1402973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591271" y="3076694"/>
            <a:ext cx="421993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2786313" y="3124200"/>
            <a:ext cx="490287" cy="13182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276600" y="3124200"/>
            <a:ext cx="381000" cy="13716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3891512" y="1804208"/>
            <a:ext cx="699759" cy="127248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3866344" y="1249812"/>
            <a:ext cx="0" cy="63624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04761171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/>
          <p:cNvCxnSpPr/>
          <p:nvPr/>
        </p:nvCxnSpPr>
        <p:spPr>
          <a:xfrm flipH="1">
            <a:off x="4273630" y="3092042"/>
            <a:ext cx="324750" cy="132755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3283170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605595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862421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134319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6" name="Straight Connector 15"/>
          <p:cNvCxnSpPr/>
          <p:nvPr/>
        </p:nvCxnSpPr>
        <p:spPr>
          <a:xfrm flipH="1">
            <a:off x="2786314" y="3124200"/>
            <a:ext cx="566486" cy="13182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352800" y="3048000"/>
            <a:ext cx="107285" cy="13716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H="1">
            <a:off x="3352800" y="1797427"/>
            <a:ext cx="494958" cy="1250573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3847757" y="1849928"/>
            <a:ext cx="758610" cy="132755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3847757" y="1499408"/>
            <a:ext cx="0" cy="34150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4591271" y="3076694"/>
            <a:ext cx="421993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35098646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38824" y="3275884"/>
            <a:ext cx="342900" cy="113431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2671230" y="1697445"/>
            <a:ext cx="1187765" cy="2835087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172685" y="2635773"/>
            <a:ext cx="266139" cy="667643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5203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3429000" y="2635773"/>
            <a:ext cx="706259" cy="1860027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3870587" y="1274802"/>
            <a:ext cx="1" cy="47779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26511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597014278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38824" y="3275884"/>
            <a:ext cx="342900" cy="113431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88215" y="1209935"/>
            <a:ext cx="1" cy="542665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172685" y="2635773"/>
            <a:ext cx="266139" cy="667643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41803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381137" y="460605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3603748" y="2666999"/>
            <a:ext cx="568937" cy="1752601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102616" y="3275884"/>
            <a:ext cx="316895" cy="114371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2682823" y="1755229"/>
            <a:ext cx="1198780" cy="280510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951773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1573622610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568875" y="2708729"/>
            <a:ext cx="603810" cy="1701465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91917" y="1202292"/>
            <a:ext cx="0" cy="55030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41803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930902" y="45486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640742" y="45486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5612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172685" y="2693489"/>
            <a:ext cx="590492" cy="1726111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172685" y="3473855"/>
            <a:ext cx="252488" cy="93633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2942428" y="1752600"/>
            <a:ext cx="949490" cy="265759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667493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905252" y="1752600"/>
            <a:ext cx="666748" cy="13716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358344" y="2329934"/>
            <a:ext cx="844264" cy="20802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207501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9530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9624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572000" y="3124200"/>
            <a:ext cx="533400" cy="12954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038600" y="3124200"/>
            <a:ext cx="533400" cy="13716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43630738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172685" y="2708729"/>
            <a:ext cx="741335" cy="171087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91917" y="1229948"/>
            <a:ext cx="1" cy="542665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41803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021842" y="459259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895600" y="457735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3603748" y="2666999"/>
            <a:ext cx="568937" cy="1752601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172685" y="3334462"/>
            <a:ext cx="307385" cy="108513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3044886" y="1772613"/>
            <a:ext cx="847032" cy="2646987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70114463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38824" y="3275884"/>
            <a:ext cx="342900" cy="113431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2931616" y="1752600"/>
            <a:ext cx="937974" cy="2667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81227" y="1752600"/>
            <a:ext cx="557597" cy="155081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48638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629930" y="456183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3499481" y="2552326"/>
            <a:ext cx="672132" cy="186727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3856323" y="1302669"/>
            <a:ext cx="1" cy="530529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80144951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452905" y="2708729"/>
            <a:ext cx="768620" cy="171087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2819400" y="1752600"/>
            <a:ext cx="1048295" cy="2667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81227" y="1752600"/>
            <a:ext cx="557597" cy="155081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29132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5523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66855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4424426" y="3285305"/>
            <a:ext cx="278798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3881227" y="1194508"/>
            <a:ext cx="0" cy="558092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00633974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38824" y="3275884"/>
            <a:ext cx="342900" cy="113431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81227" y="1752600"/>
            <a:ext cx="557597" cy="155081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24410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457257" y="456390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2743200" y="1752600"/>
            <a:ext cx="1138030" cy="2667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81226" y="1254411"/>
            <a:ext cx="1" cy="544295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3475253" y="2528008"/>
            <a:ext cx="684772" cy="188218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9626139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173200" y="2666999"/>
            <a:ext cx="608524" cy="1743195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88415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671150" y="45486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3881227" y="1752600"/>
            <a:ext cx="291973" cy="91439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3597173" y="2666999"/>
            <a:ext cx="548534" cy="1743195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2895600" y="1752600"/>
            <a:ext cx="985630" cy="265759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3871440" y="847606"/>
            <a:ext cx="0" cy="90499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22427690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24426" y="3303416"/>
            <a:ext cx="357298" cy="110677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446330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772626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4156929" y="2600606"/>
            <a:ext cx="267497" cy="70281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3881227" y="838201"/>
            <a:ext cx="0" cy="914399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H="1">
            <a:off x="2931616" y="1752600"/>
            <a:ext cx="916536" cy="265759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3881227" y="1752600"/>
            <a:ext cx="291973" cy="91439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H="1">
            <a:off x="3597173" y="2666999"/>
            <a:ext cx="548534" cy="1743195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1747408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3881227" y="1752600"/>
            <a:ext cx="900497" cy="265759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446330" y="456211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744757" y="448777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2895600" y="1740485"/>
            <a:ext cx="985628" cy="2669709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H="1">
            <a:off x="3597173" y="2666999"/>
            <a:ext cx="611202" cy="181899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3881228" y="1152807"/>
            <a:ext cx="0" cy="59979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12204341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3881227" y="1752600"/>
            <a:ext cx="900497" cy="265759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008918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59807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3452905" y="2528008"/>
            <a:ext cx="651426" cy="1811559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104331" y="3469956"/>
            <a:ext cx="343427" cy="94964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2895600" y="1740485"/>
            <a:ext cx="985628" cy="2669709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81228" y="1152807"/>
            <a:ext cx="0" cy="59979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94030448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 smtClean="0"/>
              <a:t>All Clade E Scenarios tested in DIYABC.  Scenarios 1-8 are Mediterranean ancestral, Scenarios 9-16 are English Channel England ancestral, Scenarios 17-24 are English Channel France ancestral.</a:t>
            </a:r>
            <a:endParaRPr lang="en-US" dirty="0"/>
          </a:p>
        </p:txBody>
      </p:sp>
    </p:spTree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905252" y="1752600"/>
            <a:ext cx="742948" cy="16002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4" y="2876788"/>
            <a:ext cx="621381" cy="1573292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546070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29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1910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358344" y="2897678"/>
            <a:ext cx="338569" cy="1552402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648200" y="3352800"/>
            <a:ext cx="504604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191000" y="3200400"/>
            <a:ext cx="381000" cy="12954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192322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202608" y="2329934"/>
            <a:ext cx="521792" cy="102286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358344" y="2329934"/>
            <a:ext cx="844264" cy="20802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67400" y="1600200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43600" y="3200400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43600" y="2133600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2004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29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0386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724400" y="3352800"/>
            <a:ext cx="457200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8584" y="1752600"/>
            <a:ext cx="359091" cy="67588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267200" y="3352800"/>
            <a:ext cx="457200" cy="1143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13225887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352800" y="3091934"/>
            <a:ext cx="304800" cy="140386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3091934"/>
            <a:ext cx="615835" cy="135814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1910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29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05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86200" y="1295400"/>
            <a:ext cx="19051" cy="5334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886200" y="1828800"/>
            <a:ext cx="609600" cy="13716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495800" y="3200400"/>
            <a:ext cx="657004" cy="12954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3352800" y="1828800"/>
            <a:ext cx="533400" cy="126313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H="1">
            <a:off x="4343400" y="3200400"/>
            <a:ext cx="152400" cy="12192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19232270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352800" y="3091934"/>
            <a:ext cx="304800" cy="140386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86200" y="1905000"/>
            <a:ext cx="609600" cy="12954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514600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5029200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05200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86200" y="1295400"/>
            <a:ext cx="19051" cy="6096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3352800" y="1828800"/>
            <a:ext cx="533400" cy="126313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495800" y="3200400"/>
            <a:ext cx="657004" cy="12954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4343400" y="3200400"/>
            <a:ext cx="152400" cy="12954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H="1">
            <a:off x="2686566" y="3091934"/>
            <a:ext cx="666234" cy="1512332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196093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9232270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4495800" y="3200400"/>
            <a:ext cx="684243" cy="13716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86200" y="1905000"/>
            <a:ext cx="609600" cy="12954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514600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29200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86200" y="1295400"/>
            <a:ext cx="19051" cy="6096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3352800" y="1828800"/>
            <a:ext cx="533400" cy="10668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200400" y="3200400"/>
            <a:ext cx="455643" cy="13716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4341843" y="3200400"/>
            <a:ext cx="153958" cy="140386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H="1">
            <a:off x="2686565" y="2895600"/>
            <a:ext cx="666235" cy="170866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191000" y="48006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3505200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119232270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905252" y="1752600"/>
            <a:ext cx="666748" cy="13716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358345" y="2438400"/>
            <a:ext cx="880282" cy="20574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207501" y="455676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9530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822175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6" y="2897678"/>
            <a:ext cx="671778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572000" y="3124200"/>
            <a:ext cx="533400" cy="12954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038600" y="3124200"/>
            <a:ext cx="533400" cy="13716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9608511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202608" y="2329934"/>
            <a:ext cx="521792" cy="102286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358344" y="2329934"/>
            <a:ext cx="844264" cy="20802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67400" y="1600200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43600" y="3200400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43600" y="2133600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2004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29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0386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724400" y="3352800"/>
            <a:ext cx="457200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8584" y="1752600"/>
            <a:ext cx="359091" cy="675886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267200" y="3352800"/>
            <a:ext cx="457200" cy="1143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82669630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3509187" y="2635773"/>
            <a:ext cx="663498" cy="177442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98584" y="1762836"/>
            <a:ext cx="597216" cy="1760147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91779" y="453342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558397" y="45486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509564" y="3488604"/>
            <a:ext cx="350519" cy="92159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172685" y="3460550"/>
            <a:ext cx="336879" cy="949644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24832393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3509187" y="2635773"/>
            <a:ext cx="663498" cy="177442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172685" y="2635773"/>
            <a:ext cx="266139" cy="667643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709240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438824" y="3303416"/>
            <a:ext cx="421259" cy="110677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92076798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858072" y="1752600"/>
            <a:ext cx="658175" cy="135171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39522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3546071" y="2514600"/>
            <a:ext cx="641088" cy="193548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516247" y="3091934"/>
            <a:ext cx="647860" cy="132766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3847756" y="1476494"/>
            <a:ext cx="0" cy="28204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273630" y="3079911"/>
            <a:ext cx="208520" cy="1370169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23352035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905252" y="1752600"/>
            <a:ext cx="742948" cy="16002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352800" y="3124200"/>
            <a:ext cx="369218" cy="12954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5908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505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29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043693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2743200" y="3124200"/>
            <a:ext cx="609600" cy="12954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648200" y="3352800"/>
            <a:ext cx="504604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191000" y="3200400"/>
            <a:ext cx="381000" cy="12954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3352800" y="1752600"/>
            <a:ext cx="533400" cy="13716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3886200" y="1143000"/>
            <a:ext cx="0" cy="6858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19232270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352800" y="3276600"/>
            <a:ext cx="276226" cy="12954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4341844" y="3200400"/>
            <a:ext cx="150842" cy="13716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2" name="TextBox 21"/>
          <p:cNvSpPr txBox="1"/>
          <p:nvPr/>
        </p:nvSpPr>
        <p:spPr>
          <a:xfrm>
            <a:off x="4191000" y="46482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01961" y="467195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05200" y="466007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4495800" y="3200400"/>
            <a:ext cx="657004" cy="13716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3352800" y="1752600"/>
            <a:ext cx="552452" cy="1524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H="1">
            <a:off x="2819400" y="3276600"/>
            <a:ext cx="533400" cy="12954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3886200" y="1752600"/>
            <a:ext cx="609600" cy="14478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886200" y="685800"/>
            <a:ext cx="0" cy="10668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2590800" y="467195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31192322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194191" y="2356303"/>
            <a:ext cx="530209" cy="996497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724400" y="3352800"/>
            <a:ext cx="457200" cy="10668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5029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207501" y="456541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0386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3358344" y="2356303"/>
            <a:ext cx="835847" cy="2063297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891917" y="1752600"/>
            <a:ext cx="302274" cy="603703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4267200" y="3352800"/>
            <a:ext cx="460391" cy="996497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7878151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352800" y="3124200"/>
            <a:ext cx="304800" cy="13716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114800" y="46482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5029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05200" y="465473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3886200" y="1828800"/>
            <a:ext cx="609600" cy="13716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495800" y="3200400"/>
            <a:ext cx="657004" cy="12954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590800" y="46482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</a:t>
            </a:r>
            <a:endParaRPr lang="en-US" dirty="0"/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4343400" y="3200400"/>
            <a:ext cx="152400" cy="12954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2819400" y="3124200"/>
            <a:ext cx="533400" cy="13716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H="1">
            <a:off x="3352800" y="1828800"/>
            <a:ext cx="546740" cy="12954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3886200" y="990600"/>
            <a:ext cx="0" cy="8382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19232270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>
            <a:endCxn id="24" idx="0"/>
          </p:cNvCxnSpPr>
          <p:nvPr/>
        </p:nvCxnSpPr>
        <p:spPr>
          <a:xfrm>
            <a:off x="4495800" y="3200400"/>
            <a:ext cx="684243" cy="1524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124200" y="1828800"/>
            <a:ext cx="762000" cy="16002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191000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29200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3886200" y="1828800"/>
            <a:ext cx="609600" cy="14478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200400" y="3429000"/>
            <a:ext cx="455643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2667000" y="3352800"/>
            <a:ext cx="533400" cy="12192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H="1">
            <a:off x="4343400" y="3200400"/>
            <a:ext cx="132836" cy="14478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514600" y="46482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3505200" y="47244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3886200" y="838200"/>
            <a:ext cx="0" cy="99060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19232270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4273630" y="2514600"/>
            <a:ext cx="900792" cy="186017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39522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2278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3546071" y="2514600"/>
            <a:ext cx="711604" cy="193548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 flipH="1">
            <a:off x="4257676" y="3200400"/>
            <a:ext cx="390524" cy="12192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3847756" y="1476494"/>
            <a:ext cx="0" cy="28204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831390" y="1773782"/>
            <a:ext cx="426285" cy="74081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82945030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 flipH="1">
            <a:off x="3664180" y="2666999"/>
            <a:ext cx="618243" cy="175260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276600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48967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170295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13264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03120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3855024" y="1759389"/>
            <a:ext cx="815130" cy="169247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670155" y="3451860"/>
            <a:ext cx="493952" cy="96774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H="1">
            <a:off x="4321140" y="3451860"/>
            <a:ext cx="349014" cy="99822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50151936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 flipH="1">
            <a:off x="3664180" y="2666999"/>
            <a:ext cx="618243" cy="1752601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2736965" y="1758542"/>
            <a:ext cx="1110791" cy="269153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358633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457980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282406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2535722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013264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503120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4282423" y="2666999"/>
            <a:ext cx="440842" cy="8763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723265" y="3543299"/>
            <a:ext cx="440842" cy="906781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841521" y="1354574"/>
            <a:ext cx="0" cy="40396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847756" y="1758542"/>
            <a:ext cx="434667" cy="908457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471981" y="3543299"/>
            <a:ext cx="248649" cy="90678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72967431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/>
          <p:cNvCxnSpPr/>
          <p:nvPr/>
        </p:nvCxnSpPr>
        <p:spPr>
          <a:xfrm>
            <a:off x="3847757" y="1253782"/>
            <a:ext cx="0" cy="543645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2635470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452377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013264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105202" y="461950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3" name="Straight Connector 12"/>
          <p:cNvCxnSpPr/>
          <p:nvPr/>
        </p:nvCxnSpPr>
        <p:spPr>
          <a:xfrm flipH="1">
            <a:off x="2837408" y="1797427"/>
            <a:ext cx="1010349" cy="2622173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591271" y="3076694"/>
            <a:ext cx="572836" cy="134290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342582" y="3108513"/>
            <a:ext cx="279688" cy="1311087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3847757" y="1800189"/>
            <a:ext cx="743514" cy="130832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4246012" y="3076694"/>
            <a:ext cx="299092" cy="134290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68920859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/>
          <p:cNvCxnSpPr/>
          <p:nvPr/>
        </p:nvCxnSpPr>
        <p:spPr>
          <a:xfrm flipH="1">
            <a:off x="4273631" y="3276600"/>
            <a:ext cx="298369" cy="1143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3283170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605595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862421" y="458902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134319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6" name="Straight Connector 15"/>
          <p:cNvCxnSpPr/>
          <p:nvPr/>
        </p:nvCxnSpPr>
        <p:spPr>
          <a:xfrm flipH="1">
            <a:off x="2786314" y="3177486"/>
            <a:ext cx="496856" cy="1264974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283170" y="3177486"/>
            <a:ext cx="176915" cy="12421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H="1">
            <a:off x="3283170" y="1797427"/>
            <a:ext cx="564588" cy="138005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3847757" y="1849928"/>
            <a:ext cx="724243" cy="1426672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3847757" y="1499408"/>
            <a:ext cx="0" cy="341506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4572000" y="3276600"/>
            <a:ext cx="441264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5974118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438824" y="3275884"/>
            <a:ext cx="342900" cy="113431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88215" y="1209935"/>
            <a:ext cx="1" cy="542665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172685" y="2635773"/>
            <a:ext cx="266139" cy="667643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41803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682823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3603748" y="2666999"/>
            <a:ext cx="568937" cy="1752601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102616" y="3275884"/>
            <a:ext cx="316895" cy="114371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2895600" y="1755229"/>
            <a:ext cx="986003" cy="2654965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951773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1333350455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568875" y="2708729"/>
            <a:ext cx="603810" cy="1701465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91917" y="1202292"/>
            <a:ext cx="0" cy="55030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41803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930902" y="45486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640742" y="454866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5612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4172685" y="2693489"/>
            <a:ext cx="590492" cy="1726111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172685" y="3473855"/>
            <a:ext cx="252488" cy="936339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2942428" y="1752600"/>
            <a:ext cx="949490" cy="2657594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44469540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172685" y="2708729"/>
            <a:ext cx="741335" cy="171087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3891917" y="1229948"/>
            <a:ext cx="1" cy="542665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1233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41803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021842" y="459259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895600" y="457735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3891917" y="1752600"/>
            <a:ext cx="280768" cy="914399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H="1">
            <a:off x="3603748" y="2666999"/>
            <a:ext cx="568937" cy="1752601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172685" y="3334462"/>
            <a:ext cx="307385" cy="108513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H="1">
            <a:off x="3044886" y="1772613"/>
            <a:ext cx="847032" cy="2646987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759836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4495800" y="3048000"/>
            <a:ext cx="609600" cy="14478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358344" y="2343834"/>
            <a:ext cx="844264" cy="206636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207501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8100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9530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202608" y="2343834"/>
            <a:ext cx="293192" cy="70416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3891917" y="1752600"/>
            <a:ext cx="302274" cy="603703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3962400" y="3048000"/>
            <a:ext cx="545008" cy="13716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45628886"/>
      </p:ext>
    </p:extLst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452905" y="2708729"/>
            <a:ext cx="768620" cy="1710871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2819400" y="1752600"/>
            <a:ext cx="1048295" cy="2667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881227" y="1752600"/>
            <a:ext cx="557597" cy="155081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329132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935079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5523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668557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4085922" y="3303416"/>
            <a:ext cx="338504" cy="11067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4424426" y="3285305"/>
            <a:ext cx="278798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3881227" y="1194508"/>
            <a:ext cx="0" cy="558092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76378649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858072" y="1752600"/>
            <a:ext cx="790128" cy="15240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H="1">
            <a:off x="3200400" y="1758542"/>
            <a:ext cx="647358" cy="151805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389204" y="457557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533689" y="460426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862421" y="460605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4168152" y="457557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33" name="Straight Connector 32"/>
          <p:cNvCxnSpPr/>
          <p:nvPr/>
        </p:nvCxnSpPr>
        <p:spPr>
          <a:xfrm flipH="1">
            <a:off x="2686565" y="3276600"/>
            <a:ext cx="513835" cy="1143000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4664874" y="3273922"/>
            <a:ext cx="348390" cy="1145678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3858652" y="1389703"/>
            <a:ext cx="0" cy="356462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200400" y="3273922"/>
            <a:ext cx="437978" cy="1145678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321956" y="3273922"/>
            <a:ext cx="295765" cy="1145678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83558251"/>
      </p:ext>
    </p:extLst>
  </p:cSld>
  <p:clrMapOvr>
    <a:masterClrMapping/>
  </p:clrMapOvr>
</p:sld>
</file>

<file path=ppt/slides/slide8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3881227" y="1752600"/>
            <a:ext cx="900497" cy="265759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309121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4630881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3302062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008918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2598074" y="456033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0" name="Straight Connector 19"/>
          <p:cNvCxnSpPr/>
          <p:nvPr/>
        </p:nvCxnSpPr>
        <p:spPr>
          <a:xfrm flipH="1">
            <a:off x="3452905" y="2528008"/>
            <a:ext cx="651426" cy="1891592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104331" y="3469956"/>
            <a:ext cx="343427" cy="949644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2895600" y="1740485"/>
            <a:ext cx="985628" cy="2669709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3881228" y="1152807"/>
            <a:ext cx="0" cy="599793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445104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flipH="1">
            <a:off x="3358344" y="1752600"/>
            <a:ext cx="546908" cy="1154668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3358345" y="2438400"/>
            <a:ext cx="832655" cy="198120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4517492" y="3201754"/>
            <a:ext cx="511708" cy="1294046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835936" y="1567934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t4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907568" y="423493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907568" y="2907268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907568" y="2343834"/>
            <a:ext cx="37863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3</a:t>
            </a:r>
          </a:p>
          <a:p>
            <a:endParaRPr lang="en-US" dirty="0" smtClean="0"/>
          </a:p>
        </p:txBody>
      </p:sp>
      <p:sp>
        <p:nvSpPr>
          <p:cNvPr id="21" name="TextBox 20"/>
          <p:cNvSpPr txBox="1"/>
          <p:nvPr/>
        </p:nvSpPr>
        <p:spPr>
          <a:xfrm>
            <a:off x="2479087" y="45737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48768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8862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3200400" y="457200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cxnSp>
        <p:nvCxnSpPr>
          <p:cNvPr id="29" name="Straight Connector 28"/>
          <p:cNvCxnSpPr/>
          <p:nvPr/>
        </p:nvCxnSpPr>
        <p:spPr>
          <a:xfrm flipH="1">
            <a:off x="3891917" y="1295400"/>
            <a:ext cx="13334" cy="455414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H="1">
            <a:off x="2686565" y="2897678"/>
            <a:ext cx="671779" cy="1512516"/>
          </a:xfrm>
          <a:prstGeom prst="line">
            <a:avLst/>
          </a:prstGeom>
          <a:ln w="381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905252" y="1754624"/>
            <a:ext cx="666748" cy="1598176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 flipH="1">
            <a:off x="4038600" y="3352800"/>
            <a:ext cx="533400" cy="114300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82563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5897</Words>
  <Application>Microsoft Office PowerPoint</Application>
  <PresentationFormat>On-screen Show (4:3)</PresentationFormat>
  <Paragraphs>1024</Paragraphs>
  <Slides>82</Slides>
  <Notes>79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2</vt:i4>
      </vt:variant>
    </vt:vector>
  </HeadingPairs>
  <TitlesOfParts>
    <vt:vector size="83" baseType="lpstr">
      <vt:lpstr>Office Theme</vt:lpstr>
      <vt:lpstr>Supporting Information Table 3: Visualizations of Clade A and Clade E DIYABC scenarios  </vt:lpstr>
      <vt:lpstr>All Clade A Scenarios tested in DIYABC.  Scenarios 1-12 are Mediterranean ancestral, Scenarios 13, 16-27 are Pacific ancestral, Scenarios 14, 28-41 are northeastern Atlantic ancestral, and Scenarios 15, 42-55 are northwestern Atlantic ancestral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All Clade E Scenarios tested in DIYABC.  Scenarios 1-8 are Mediterranean ancestral, Scenarios 9-16 are English Channel England ancestral, Scenarios 17-24 are English Channel France ancestral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vasion history of two clades in the Botryllus schlosseri species complex  Biological Invasions  Marie L. Nydam, Kirsten B. Giesbrecht, Emily E. Stephenson  Centre College  marie.nydam@centre.edu  </dc:title>
  <dc:creator>Marie</dc:creator>
  <cp:lastModifiedBy>Marie L. Nydam</cp:lastModifiedBy>
  <cp:revision>9</cp:revision>
  <dcterms:created xsi:type="dcterms:W3CDTF">2006-08-16T00:00:00Z</dcterms:created>
  <dcterms:modified xsi:type="dcterms:W3CDTF">2016-12-16T20:57:01Z</dcterms:modified>
</cp:coreProperties>
</file>